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91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42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37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6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73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15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4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5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568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2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8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1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10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25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F744FB5-9D41-4021-BFC2-DBDDD51882C0}"/>
              </a:ext>
            </a:extLst>
          </p:cNvPr>
          <p:cNvSpPr txBox="1"/>
          <p:nvPr/>
        </p:nvSpPr>
        <p:spPr>
          <a:xfrm>
            <a:off x="168301" y="8932708"/>
            <a:ext cx="63080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clade credibility (MCC) tree of MDV strains using the evolutionary model GTR+Γ4 based on the UL (A), IRS (B), and IRL (C) sub-regional sequences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59C7B98-87F2-47D3-AF44-8EE552BD245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438" y="142296"/>
            <a:ext cx="5074258" cy="279062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CB8E328-F989-4FBE-A468-8F04B9912CFC}"/>
              </a:ext>
            </a:extLst>
          </p:cNvPr>
          <p:cNvSpPr txBox="1"/>
          <p:nvPr/>
        </p:nvSpPr>
        <p:spPr>
          <a:xfrm>
            <a:off x="197458" y="334114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595299C5-2575-4C3F-B259-2BEA7229F63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438" y="2932924"/>
            <a:ext cx="5074258" cy="279062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B17D72FB-21B5-4C8E-BDB8-0A37BA4871CB}"/>
              </a:ext>
            </a:extLst>
          </p:cNvPr>
          <p:cNvSpPr txBox="1"/>
          <p:nvPr/>
        </p:nvSpPr>
        <p:spPr>
          <a:xfrm>
            <a:off x="225287" y="3123876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10F4DE4A-D101-4A1A-9ECD-47783C3BE5F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0438" y="5883256"/>
            <a:ext cx="5193527" cy="2856221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DD9031FE-8874-4DE6-B126-51FE56A1FD26}"/>
              </a:ext>
            </a:extLst>
          </p:cNvPr>
          <p:cNvSpPr txBox="1"/>
          <p:nvPr/>
        </p:nvSpPr>
        <p:spPr>
          <a:xfrm>
            <a:off x="324679" y="5913638"/>
            <a:ext cx="5433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983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</TotalTime>
  <Words>42</Words>
  <Application>Microsoft Office PowerPoint</Application>
  <PresentationFormat>A4 纸张(210x297 毫米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 Li</dc:creator>
  <cp:lastModifiedBy>Andy Lee</cp:lastModifiedBy>
  <cp:revision>17</cp:revision>
  <dcterms:created xsi:type="dcterms:W3CDTF">2020-10-24T12:47:24Z</dcterms:created>
  <dcterms:modified xsi:type="dcterms:W3CDTF">2022-10-25T13:28:46Z</dcterms:modified>
</cp:coreProperties>
</file>